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ED4CFF"/>
    <a:srgbClr val="A473FF"/>
    <a:srgbClr val="FF9C4B"/>
    <a:srgbClr val="A1C447"/>
    <a:srgbClr val="8B961D"/>
    <a:srgbClr val="68CF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85" autoAdjust="0"/>
    <p:restoredTop sz="94852" autoAdjust="0"/>
  </p:normalViewPr>
  <p:slideViewPr>
    <p:cSldViewPr snapToGrid="0" snapToObjects="1">
      <p:cViewPr>
        <p:scale>
          <a:sx n="152" d="100"/>
          <a:sy n="152" d="100"/>
        </p:scale>
        <p:origin x="-616" y="-6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DA6643-8E32-9A4C-AD52-F8801A2A5AF1}" type="datetimeFigureOut">
              <a:rPr lang="en-US" smtClean="0"/>
              <a:t>9/30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CE494E-83A9-D94F-9BBD-407B3C248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9454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379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084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069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93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529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177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129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030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587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290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958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D9B88-68D5-6043-A568-A8B8D3B4C326}" type="datetimeFigureOut">
              <a:rPr lang="en-US" smtClean="0"/>
              <a:pPr/>
              <a:t>9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800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3307702"/>
              </p:ext>
            </p:extLst>
          </p:nvPr>
        </p:nvGraphicFramePr>
        <p:xfrm>
          <a:off x="158750" y="267264"/>
          <a:ext cx="2899410" cy="7483391"/>
        </p:xfrm>
        <a:graphic>
          <a:graphicData uri="http://schemas.openxmlformats.org/drawingml/2006/table">
            <a:tbl>
              <a:tblPr/>
              <a:tblGrid>
                <a:gridCol w="928370"/>
                <a:gridCol w="812800"/>
                <a:gridCol w="1158240"/>
              </a:tblGrid>
              <a:tr h="2443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ystematic nam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llel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GA scor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ML010W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pt5-19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1.2958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OR122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fy1-1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1.2008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HR170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nmd3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1.1686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L050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of1-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1.040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1.0352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GR00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ec9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9918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OR122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fy1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9700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268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ec22-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9468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EL026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nu13-L67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9391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062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cb2-1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8905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GL073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hsf1-84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8744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L014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nop1-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8611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15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85168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440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ec39-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8454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459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gab1-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8182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CR002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700" b="0" i="1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dc10-</a:t>
                      </a:r>
                      <a:r>
                        <a:rPr lang="cs-CZ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8145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473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rp3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8139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PR110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pc40-V78R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</a:t>
                      </a: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0.8101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KL173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nu114-6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771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JL001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re3-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669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HR166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dc23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602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168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dc37-ts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577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BL034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tu1-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525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12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318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272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NR026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ec12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257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NL102W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ol1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235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212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ub4-ΔDSY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7027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OR181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as17-1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9864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NL102W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ol1-ts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977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MR168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ep3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933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MR235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na1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85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BR237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rp5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643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GL098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use1-ts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635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052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dbf4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630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R028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dc14-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568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08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mc1-25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563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OR257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dc31-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55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632" y="13596"/>
            <a:ext cx="5207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Supplementary file </a:t>
            </a:r>
            <a:r>
              <a:rPr lang="en-US" sz="800" dirty="0">
                <a:latin typeface="Helvetica"/>
                <a:cs typeface="Helvetica"/>
              </a:rPr>
              <a:t>2</a:t>
            </a:r>
            <a:r>
              <a:rPr lang="en-US" sz="800" dirty="0" smtClean="0">
                <a:latin typeface="Helvetica"/>
                <a:cs typeface="Helvetica"/>
              </a:rPr>
              <a:t>  </a:t>
            </a:r>
            <a:r>
              <a:rPr lang="en-US" sz="800" dirty="0" smtClean="0">
                <a:latin typeface="Helvetica"/>
                <a:cs typeface="Helvetica"/>
              </a:rPr>
              <a:t>List of ts alleles that increased mHtt103QP toxicity in SGA screen.</a:t>
            </a:r>
            <a:endParaRPr lang="en-US" sz="800" dirty="0">
              <a:latin typeface="Helvetica"/>
              <a:cs typeface="Helvetica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4259967"/>
              </p:ext>
            </p:extLst>
          </p:nvPr>
        </p:nvGraphicFramePr>
        <p:xfrm>
          <a:off x="3315147" y="257786"/>
          <a:ext cx="2899410" cy="7483391"/>
        </p:xfrm>
        <a:graphic>
          <a:graphicData uri="http://schemas.openxmlformats.org/drawingml/2006/table">
            <a:tbl>
              <a:tblPr/>
              <a:tblGrid>
                <a:gridCol w="928370"/>
                <a:gridCol w="812800"/>
                <a:gridCol w="1158240"/>
              </a:tblGrid>
              <a:tr h="2443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ystematic nam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llel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GA scor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440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ec39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419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1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389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09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dc4-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383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JR065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rp3-G302Y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379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208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ss4</a:t>
                      </a:r>
                      <a:r>
                        <a:rPr lang="is-IS" sz="700" b="0" i="1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103</a:t>
                      </a:r>
                      <a:endParaRPr lang="is-I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35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088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lu7-ts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338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PR055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ec8-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318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L064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ubc9-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265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ER008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ec3-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253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L028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ps1-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178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JR065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rp3-D11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6060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12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992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060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ak21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8293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045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tu2-1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80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BL050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ec17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792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L017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dc7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747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303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sc3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734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IL118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ho3-Ser22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714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HR191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tf8-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683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BR198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af5-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6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MR235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na1-S116F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624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13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576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243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rp28</a:t>
                      </a:r>
                      <a:r>
                        <a:rPr lang="en-US" sz="700" b="0" i="1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10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560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OR326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u-HU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yo2-1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428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MR197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vti1-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</a:t>
                      </a: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0.54107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LR305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tt4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3541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GR156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ti1-ts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321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060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ak21-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305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IR006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an1-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2572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13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197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GL022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tt3-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18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12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148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478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nm1-17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141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FL039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ct1-11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13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DR182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700" b="0" i="1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dc1-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085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JR093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p1-43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049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ER125W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sp5-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0.5019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56112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>
          <a:tailEnd type="arrow"/>
        </a:ln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23</TotalTime>
  <Words>475</Words>
  <Application>Microsoft Macintosh PowerPoint</Application>
  <PresentationFormat>On-screen Show (4:3)</PresentationFormat>
  <Paragraphs>2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Nyström</dc:creator>
  <cp:lastModifiedBy>Junsheng Yang</cp:lastModifiedBy>
  <cp:revision>1208</cp:revision>
  <cp:lastPrinted>2014-10-20T06:32:57Z</cp:lastPrinted>
  <dcterms:created xsi:type="dcterms:W3CDTF">2013-02-25T19:20:10Z</dcterms:created>
  <dcterms:modified xsi:type="dcterms:W3CDTF">2015-10-01T03:59:28Z</dcterms:modified>
</cp:coreProperties>
</file>